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6" r:id="rId2"/>
  </p:sldIdLst>
  <p:sldSz cx="165592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5" d="100"/>
          <a:sy n="55" d="100"/>
        </p:scale>
        <p:origin x="19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KSA\TRIAGE\TRIAGE_ProADM\Graph_FINAL_analyse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W$37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A83-436C-AECE-367DF8663BA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CA83-436C-AECE-367DF8663BA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CA83-436C-AECE-367DF8663BA4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A83-436C-AECE-367DF8663BA4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A83-436C-AECE-367DF8663BA4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CA83-436C-AECE-367DF8663BA4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CA83-436C-AECE-367DF8663BA4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A83-436C-AECE-367DF8663BA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CEB0EBB0-271C-4BDB-B8A1-442D37B0EBB8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5/37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CA83-436C-AECE-367DF8663BA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08C52BE2-8F7B-4557-A5FE-6C5CE167FD82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9/32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CA83-436C-AECE-367DF8663BA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7BDE5F2D-B751-48ED-8768-E3DD5CD3BDBB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28/16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CA83-436C-AECE-367DF8663BA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CDA1278E-C25A-4034-B2ED-4E85A5B73133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0/26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CA83-436C-AECE-367DF8663BA4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70FED21F-3E1C-49F3-9AD1-47851C87880C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8/31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CA83-436C-AECE-367DF8663BA4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B365359A-96BE-4CB6-83D1-B40F208178C9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4/288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CA83-436C-AECE-367DF8663BA4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09B8B802-0968-4803-9075-C7A95BCEFE86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2/37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CA83-436C-AECE-367DF8663BA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0E08184C-2358-4494-B88B-6AD5057D28F7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5/21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CA83-436C-AECE-367DF8663BA4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40590D87-EEFF-4469-A8AC-1CC7F7DBD3B3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5/28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CA83-436C-AECE-367DF8663BA4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C29909D3-A46A-4982-ACD2-71F3322B5355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/37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CA83-436C-AECE-367DF8663BA4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4924C889-E230-41AC-B39A-97B087C444E7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5/23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CA83-436C-AECE-367DF8663BA4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5D73D8AC-014E-403C-B7DA-79C2E9FE38F9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6/26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CA83-436C-AECE-367DF8663BA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X$32:$AI$33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X$37:$AI$37</c:f>
              <c:numCache>
                <c:formatCode>0.0%</c:formatCode>
                <c:ptCount val="12"/>
                <c:pt idx="0">
                  <c:v>1.3404825737265416E-2</c:v>
                </c:pt>
                <c:pt idx="1">
                  <c:v>5.8282208588957052E-2</c:v>
                </c:pt>
                <c:pt idx="2">
                  <c:v>0.16867469879518071</c:v>
                </c:pt>
                <c:pt idx="3">
                  <c:v>0</c:v>
                </c:pt>
                <c:pt idx="4">
                  <c:v>2.564102564102564E-2</c:v>
                </c:pt>
                <c:pt idx="5">
                  <c:v>0.15277777777777779</c:v>
                </c:pt>
                <c:pt idx="6">
                  <c:v>5.3619302949061663E-3</c:v>
                </c:pt>
                <c:pt idx="7">
                  <c:v>2.3809523809523808E-2</c:v>
                </c:pt>
                <c:pt idx="8">
                  <c:v>0.15957446808510639</c:v>
                </c:pt>
                <c:pt idx="9">
                  <c:v>2.6809651474530832E-3</c:v>
                </c:pt>
                <c:pt idx="10">
                  <c:v>2.1739130434782608E-2</c:v>
                </c:pt>
                <c:pt idx="11">
                  <c:v>0.17557251908396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A83-436C-AECE-367DF8663B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W$63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37-4807-8AFE-2A0C99A740B9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1937-4807-8AFE-2A0C99A740B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1937-4807-8AFE-2A0C99A740B9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937-4807-8AFE-2A0C99A740B9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937-4807-8AFE-2A0C99A740B9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1937-4807-8AFE-2A0C99A740B9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1937-4807-8AFE-2A0C99A740B9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937-4807-8AFE-2A0C99A740B9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AB4A6DE4-BD87-45FE-B940-9F9BAE1ACB07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7/56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1937-4807-8AFE-2A0C99A740B9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725111E4-B7E6-4322-8FE9-E44725CA7931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22/57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1937-4807-8AFE-2A0C99A740B9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F9ADE6D0-5B11-4E49-98E4-767EF30B8931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36/53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1937-4807-8AFE-2A0C99A740B9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C2EE2F0D-58F2-4EB0-98AC-E94AC54A2417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/77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1937-4807-8AFE-2A0C99A740B9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80E9CE65-34BB-479D-82AC-16ADA1EDB4BF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5/59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1937-4807-8AFE-2A0C99A740B9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E54F34A0-3ECF-4313-B62A-D4E73D81D6CF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9/30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1937-4807-8AFE-2A0C99A740B9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11DC12B7-6D7A-4C8F-BCF6-BB8A0928CD8F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3/74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1937-4807-8AFE-2A0C99A740B9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2505D29F-AFF2-464B-AA81-0B1D3A9B1F51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8/43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1937-4807-8AFE-2A0C99A740B9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025050AF-871B-41EC-9D31-78B83D67BA8C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54/49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1937-4807-8AFE-2A0C99A740B9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64EE61E7-53EC-4280-AC5A-CA2AEE32B21D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3/93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1937-4807-8AFE-2A0C99A740B9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8B5322A8-7E81-4297-9D50-B15CD79BED78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8/37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1937-4807-8AFE-2A0C99A740B9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EB47259D-84FE-45C4-8EDC-587EF040C278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54/36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1937-4807-8AFE-2A0C99A740B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X$58:$AI$59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X$63:$AI$63</c:f>
              <c:numCache>
                <c:formatCode>0.0%</c:formatCode>
                <c:ptCount val="12"/>
                <c:pt idx="0">
                  <c:v>1.2411347517730497E-2</c:v>
                </c:pt>
                <c:pt idx="1">
                  <c:v>3.8128249566724434E-2</c:v>
                </c:pt>
                <c:pt idx="2">
                  <c:v>6.7924528301886791E-2</c:v>
                </c:pt>
                <c:pt idx="3">
                  <c:v>1.2903225806451613E-3</c:v>
                </c:pt>
                <c:pt idx="4">
                  <c:v>2.5210084033613446E-2</c:v>
                </c:pt>
                <c:pt idx="5">
                  <c:v>0.16279069767441862</c:v>
                </c:pt>
                <c:pt idx="6">
                  <c:v>4.0540540540540543E-3</c:v>
                </c:pt>
                <c:pt idx="7">
                  <c:v>1.8223234624145785E-2</c:v>
                </c:pt>
                <c:pt idx="8">
                  <c:v>0.10975609756097561</c:v>
                </c:pt>
                <c:pt idx="9">
                  <c:v>3.2119914346895075E-3</c:v>
                </c:pt>
                <c:pt idx="10">
                  <c:v>2.1220159151193633E-2</c:v>
                </c:pt>
                <c:pt idx="11">
                  <c:v>0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937-4807-8AFE-2A0C99A740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W$86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E61-45F4-A886-537D610CFF6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FE61-45F4-A886-537D610CFF6E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FE61-45F4-A886-537D610CFF6E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E61-45F4-A886-537D610CFF6E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E61-45F4-A886-537D610CFF6E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FE61-45F4-A886-537D610CFF6E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FE61-45F4-A886-537D610CFF6E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E61-45F4-A886-537D610CFF6E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D6359941-0C43-4BBB-9418-F93954BA5FD6}" type="VALUE">
                      <a:rPr lang="en-US" smtClean="0"/>
                      <a:pPr/>
                      <a:t>[WERT]</a:t>
                    </a:fld>
                    <a:r>
                      <a:rPr lang="en-US" dirty="0"/>
                      <a:t> </a:t>
                    </a:r>
                  </a:p>
                  <a:p>
                    <a:r>
                      <a:rPr lang="en-US" dirty="0"/>
                      <a:t>(7/54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FE61-45F4-A886-537D610CFF6E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C1885401-EA98-4997-9D7A-B877715E731E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1/428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FE61-45F4-A886-537D610CFF6E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638FF715-226D-4A53-B6B1-8B06DE552424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0/40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FE61-45F4-A886-537D610CFF6E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D75389E0-1D5F-4D22-95C7-7E3D68829E1A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9/74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FE61-45F4-A886-537D610CFF6E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5E158507-DCFE-4C82-ACA6-F4C32DAB26AC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34/52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FE61-45F4-A886-537D610CFF6E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E5BEB162-2C06-4701-ACF6-4A838A8A0702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5/9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FE61-45F4-A886-537D610CFF6E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C5AF596F-5F48-4B0E-A990-0F4325618D03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7/73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FE61-45F4-A886-537D610CFF6E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276F1FB5-0DB7-4D78-BD40-F368C8C364DE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2/34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FE61-45F4-A886-537D610CFF6E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7D90AB1B-9CFF-4BFE-B843-248EA9544679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39/29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FE61-45F4-A886-537D610CFF6E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59CCC638-2081-4FCC-BC67-BAC657E49757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/53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FE61-45F4-A886-537D610CFF6E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7F5A3572-C8CD-4242-A64E-9639C9DBB543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12/45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FE61-45F4-A886-537D610CFF6E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AB4DE71B-A845-4388-82D2-388E1B7AB1F9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5/39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FE61-45F4-A886-537D610CFF6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X$81:$AI$82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X$86:$AI$86</c:f>
              <c:numCache>
                <c:formatCode>0.0%</c:formatCode>
                <c:ptCount val="12"/>
                <c:pt idx="0">
                  <c:v>1.2867647058823529E-2</c:v>
                </c:pt>
                <c:pt idx="1">
                  <c:v>2.5700934579439252E-2</c:v>
                </c:pt>
                <c:pt idx="2">
                  <c:v>9.9255583126550875E-2</c:v>
                </c:pt>
                <c:pt idx="3">
                  <c:v>1.2016021361815754E-2</c:v>
                </c:pt>
                <c:pt idx="4">
                  <c:v>6.4516129032258063E-2</c:v>
                </c:pt>
                <c:pt idx="5">
                  <c:v>0.15151515151515152</c:v>
                </c:pt>
                <c:pt idx="6">
                  <c:v>9.5497953615279671E-3</c:v>
                </c:pt>
                <c:pt idx="7">
                  <c:v>3.4383954154727794E-2</c:v>
                </c:pt>
                <c:pt idx="8">
                  <c:v>0.13310580204778158</c:v>
                </c:pt>
                <c:pt idx="9">
                  <c:v>1.8796992481203006E-3</c:v>
                </c:pt>
                <c:pt idx="10">
                  <c:v>2.6607538802660754E-2</c:v>
                </c:pt>
                <c:pt idx="11">
                  <c:v>0.114795918367346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E61-45F4-A886-537D610CFF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AQ$37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0FA-48BB-87F1-7BF35983391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E0FA-48BB-87F1-7BF35983391E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E0FA-48BB-87F1-7BF35983391E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0FA-48BB-87F1-7BF35983391E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0FA-48BB-87F1-7BF35983391E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E0FA-48BB-87F1-7BF35983391E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E0FA-48BB-87F1-7BF35983391E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0FA-48BB-87F1-7BF35983391E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FE9CAE4A-1D52-4BBC-A477-0770BAC0B3F4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3/39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E0FA-48BB-87F1-7BF35983391E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EA54E0F6-3ACA-4256-84B8-A4E260106744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3/28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E0FA-48BB-87F1-7BF35983391E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965BCA5A-3FB9-4A96-85DB-961C717D1E9A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8/32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E0FA-48BB-87F1-7BF35983391E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967D0F96-0496-4B33-9AB8-F176B5EC317F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/61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E0FA-48BB-87F1-7BF35983391E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4798C2EE-0607-4D47-91B9-6EACEE00259E}" type="VALUE">
                      <a:rPr lang="en-US" smtClean="0"/>
                      <a:pPr/>
                      <a:t>[WERT]</a:t>
                    </a:fld>
                    <a:r>
                      <a:rPr lang="en-US"/>
                      <a:t> </a:t>
                    </a:r>
                  </a:p>
                  <a:p>
                    <a:r>
                      <a:rPr lang="en-US"/>
                      <a:t>(4/32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E0FA-48BB-87F1-7BF35983391E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45C587AD-4521-4DC2-851C-361E4DF14A3C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9/58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E0FA-48BB-87F1-7BF35983391E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F97A2899-6724-44D9-A9C2-482FDB3B7ABD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/54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E0FA-48BB-87F1-7BF35983391E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A1C7E8C6-35FD-49D7-BEF7-D4C56F372E09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/26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E0FA-48BB-87F1-7BF35983391E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D3B199D8-0C86-426F-B2FE-0191E365F1D9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0/19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E0FA-48BB-87F1-7BF35983391E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9039C8EC-E042-457C-870B-44E0B7948461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/78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E0FA-48BB-87F1-7BF35983391E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804D66A8-6FE9-494F-AEB4-3B1E66E7FB6F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6/15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E0FA-48BB-87F1-7BF35983391E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18B5ACC8-E6B3-4B9A-860D-B6B662FA41CC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7/5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E0FA-48BB-87F1-7BF35983391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AR$32:$BC$33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AR$37:$BC$37</c:f>
              <c:numCache>
                <c:formatCode>0.0%</c:formatCode>
                <c:ptCount val="12"/>
                <c:pt idx="0">
                  <c:v>7.6726342710997444E-3</c:v>
                </c:pt>
                <c:pt idx="1">
                  <c:v>1.0563380281690141E-2</c:v>
                </c:pt>
                <c:pt idx="2">
                  <c:v>2.4844720496894408E-2</c:v>
                </c:pt>
                <c:pt idx="3">
                  <c:v>1.6155088852988692E-3</c:v>
                </c:pt>
                <c:pt idx="4">
                  <c:v>1.2500000000000001E-2</c:v>
                </c:pt>
                <c:pt idx="5">
                  <c:v>0.15517241379310345</c:v>
                </c:pt>
                <c:pt idx="6">
                  <c:v>3.6832412523020259E-3</c:v>
                </c:pt>
                <c:pt idx="7">
                  <c:v>7.6045627376425855E-3</c:v>
                </c:pt>
                <c:pt idx="8">
                  <c:v>5.2356020942408377E-2</c:v>
                </c:pt>
                <c:pt idx="9">
                  <c:v>1.2755102040816326E-3</c:v>
                </c:pt>
                <c:pt idx="10">
                  <c:v>3.8216560509554139E-2</c:v>
                </c:pt>
                <c:pt idx="11">
                  <c:v>0.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0FA-48BB-87F1-7BF3598339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AQ$11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F17-441A-927B-C11228DABCE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F17-441A-927B-C11228DABCE8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0F17-441A-927B-C11228DABCE8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F17-441A-927B-C11228DABCE8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F17-441A-927B-C11228DABCE8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0F17-441A-927B-C11228DABCE8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0F17-441A-927B-C11228DABCE8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F17-441A-927B-C11228DABCE8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B59D7201-A2B6-4BCF-9C07-DE538AD01CD7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9/66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0F17-441A-927B-C11228DABCE8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D15C137C-63D8-4FF8-B59D-5633D34DB303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3/35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0F17-441A-927B-C11228DABCE8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C4F1EB35-B247-4775-A84C-B474C91F6D4D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0/9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0F17-441A-927B-C11228DABCE8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AC696716-C0AD-4249-BDD4-0C9FF5A2BC9C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/70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0F17-441A-927B-C11228DABCE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8ED183FB-08A2-4C78-978E-0EBC0686753D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2/29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0F17-441A-927B-C11228DABCE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90E12F9C-AF0A-4AF3-83A3-91A7FD942068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8/11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0F17-441A-927B-C11228DABCE8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6A88EF23-7D2D-47CC-9667-67B7A3C66791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6/798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0F17-441A-927B-C11228DABCE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FBA16FA7-16E4-49B2-97A9-FD08352D4865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9/20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0F17-441A-927B-C11228DABCE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A3B48217-B5A9-4782-B7B6-E2B69617D336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7/11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0F17-441A-927B-C11228DABCE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DF0A7ED6-FB02-4A4C-85BD-0C987FF9B6A1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0/77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0F17-441A-927B-C11228DABCE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C0B39787-E972-4B5A-8A77-9F52A36BA14F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8/20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0F17-441A-927B-C11228DABCE8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AB8151C3-A4F8-40D0-A17B-1F1DE101AE1C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4/13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0F17-441A-927B-C11228DABCE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AR$6:$BC$7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AR$11:$BC$11</c:f>
              <c:numCache>
                <c:formatCode>0.0%</c:formatCode>
                <c:ptCount val="12"/>
                <c:pt idx="0">
                  <c:v>1.3533834586466165E-2</c:v>
                </c:pt>
                <c:pt idx="1">
                  <c:v>3.6827195467422094E-2</c:v>
                </c:pt>
                <c:pt idx="2">
                  <c:v>0.10526315789473684</c:v>
                </c:pt>
                <c:pt idx="3">
                  <c:v>2.8328611898016999E-3</c:v>
                </c:pt>
                <c:pt idx="4">
                  <c:v>4.0404040404040407E-2</c:v>
                </c:pt>
                <c:pt idx="5">
                  <c:v>0.16363636363636364</c:v>
                </c:pt>
                <c:pt idx="6">
                  <c:v>7.5187969924812026E-3</c:v>
                </c:pt>
                <c:pt idx="7">
                  <c:v>4.4117647058823532E-2</c:v>
                </c:pt>
                <c:pt idx="8">
                  <c:v>0.15315315315315314</c:v>
                </c:pt>
                <c:pt idx="9">
                  <c:v>0</c:v>
                </c:pt>
                <c:pt idx="10">
                  <c:v>3.864734299516908E-2</c:v>
                </c:pt>
                <c:pt idx="11">
                  <c:v>0.176470588235294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F17-441A-927B-C11228DABC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AQ$63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443-4C38-AEC1-22257F57AF8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9443-4C38-AEC1-22257F57AF8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9443-4C38-AEC1-22257F57AF84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443-4C38-AEC1-22257F57AF84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443-4C38-AEC1-22257F57AF84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9443-4C38-AEC1-22257F57AF84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9443-4C38-AEC1-22257F57AF84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443-4C38-AEC1-22257F57AF8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A3824E70-26AB-40B6-8B57-1AE744CA72FA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8/43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9443-4C38-AEC1-22257F57AF8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1E069448-A3A4-4F27-9551-35EACCD3B24E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1/36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9443-4C38-AEC1-22257F57AF8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77D61883-1DC2-4055-B52D-EEC1F8B8B162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45/43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9443-4C38-AEC1-22257F57AF8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887ED5B4-E2F0-42E5-90C7-698051A8A281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8/58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9443-4C38-AEC1-22257F57AF84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B0D66023-84DB-4A64-9174-898D880B5745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32/50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9443-4C38-AEC1-22257F57AF84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47931714-14B8-4F59-B7E1-BB7CE8C38546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4/13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9443-4C38-AEC1-22257F57AF84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5118CBD6-1CAB-4F11-BA84-44BCD8271B1D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6/573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9443-4C38-AEC1-22257F57AF8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A9E80835-2D26-4D51-872D-6889BC403AB6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3/31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9443-4C38-AEC1-22257F57AF84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609B3635-9598-4C8A-B818-13946B18F803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45/33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9443-4C38-AEC1-22257F57AF84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17DE8362-A059-444F-A5A8-8FA2715001D6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/38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9443-4C38-AEC1-22257F57AF84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43E0D2CE-B010-4623-B4E2-0E41928DAC17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1/41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9443-4C38-AEC1-22257F57AF84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61CE3DC3-7C3C-4483-87EF-87FCCB7B8830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52/429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9443-4C38-AEC1-22257F57AF8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AR$58:$BC$59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AR$63:$BC$63</c:f>
              <c:numCache>
                <c:formatCode>0.0%</c:formatCode>
                <c:ptCount val="12"/>
                <c:pt idx="0">
                  <c:v>1.8561484918793503E-2</c:v>
                </c:pt>
                <c:pt idx="1">
                  <c:v>3.0386740331491711E-2</c:v>
                </c:pt>
                <c:pt idx="2">
                  <c:v>0.10440835266821345</c:v>
                </c:pt>
                <c:pt idx="3">
                  <c:v>1.3698630136986301E-2</c:v>
                </c:pt>
                <c:pt idx="4">
                  <c:v>6.3241106719367585E-2</c:v>
                </c:pt>
                <c:pt idx="5">
                  <c:v>0.17910447761194029</c:v>
                </c:pt>
                <c:pt idx="6">
                  <c:v>1.0471204188481676E-2</c:v>
                </c:pt>
                <c:pt idx="7">
                  <c:v>4.0752351097178681E-2</c:v>
                </c:pt>
                <c:pt idx="8">
                  <c:v>0.13554216867469879</c:v>
                </c:pt>
                <c:pt idx="9">
                  <c:v>2.5974025974025974E-3</c:v>
                </c:pt>
                <c:pt idx="10">
                  <c:v>2.6829268292682926E-2</c:v>
                </c:pt>
                <c:pt idx="11">
                  <c:v>0.121212121212121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443-4C38-AEC1-22257F57AF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84661835748772E-2"/>
          <c:y val="5.5953174603174602E-2"/>
          <c:w val="0.90077536231884059"/>
          <c:h val="0.65113399416788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4!$AQ$86</c:f>
              <c:strCache>
                <c:ptCount val="1"/>
                <c:pt idx="0">
                  <c:v>Non-survivors %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D7F-4996-9515-DA1A9CC107A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DD7F-4996-9515-DA1A9CC107A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DD7F-4996-9515-DA1A9CC107A2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D7F-4996-9515-DA1A9CC107A2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D7F-4996-9515-DA1A9CC107A2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DD7F-4996-9515-DA1A9CC107A2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DD7F-4996-9515-DA1A9CC107A2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D7F-4996-9515-DA1A9CC107A2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D81EF22F-87E3-45C6-BDB2-084A755E2EC4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4/22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DD7F-4996-9515-DA1A9CC107A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5EC948BB-6E88-4A9C-A4EA-90947B77742D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33/41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D7F-4996-9515-DA1A9CC107A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FEED049C-4362-4CA5-9A91-1278E406588E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40/30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DD7F-4996-9515-DA1A9CC107A2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B1965F59-2E20-408D-9145-65B0D7ED5185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/24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D7F-4996-9515-DA1A9CC107A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F91E71DD-1663-4631-83CE-E1B046274710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20/36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DD7F-4996-9515-DA1A9CC107A2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18E6BA83-FE9C-46E0-B51C-958E1D7C23FD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65/32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DD7F-4996-9515-DA1A9CC107A2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AF4E14ED-E036-4DC8-A8F4-67C854F6903E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5/275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DD7F-4996-9515-DA1A9CC107A2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56F0E1DF-2A61-4AE1-80D7-EE2D14F6D384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6/26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DD7F-4996-9515-DA1A9CC107A2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5CEB0F4C-3B50-4DF6-AC9F-49B7AE53D90B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66/398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DD7F-4996-9515-DA1A9CC107A2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15B4B7A9-2EFE-48C8-B098-1AB12C3744A5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1/221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DD7F-4996-9515-DA1A9CC107A2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B644BF4E-8855-4E5C-ADA8-793314EA17D5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9/24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DD7F-4996-9515-DA1A9CC107A2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1D165189-6DDA-4444-841B-7C45A7F3C067}" type="VALUE">
                      <a:rPr lang="en-US" smtClean="0"/>
                      <a:pPr/>
                      <a:t>[WERT]</a:t>
                    </a:fld>
                    <a:endParaRPr lang="en-US"/>
                  </a:p>
                  <a:p>
                    <a:r>
                      <a:rPr lang="en-US"/>
                      <a:t>(77/470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DD7F-4996-9515-DA1A9CC107A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Tabelle4!$AR$81:$BC$82</c:f>
              <c:multiLvlStrCache>
                <c:ptCount val="12"/>
                <c:lvl>
                  <c:pt idx="0">
                    <c:v>Low risk</c:v>
                  </c:pt>
                  <c:pt idx="1">
                    <c:v>Mod. risk</c:v>
                  </c:pt>
                  <c:pt idx="2">
                    <c:v>High risk</c:v>
                  </c:pt>
                  <c:pt idx="3">
                    <c:v>Low risk</c:v>
                  </c:pt>
                  <c:pt idx="4">
                    <c:v>Mod. risk</c:v>
                  </c:pt>
                  <c:pt idx="5">
                    <c:v>High risk</c:v>
                  </c:pt>
                  <c:pt idx="6">
                    <c:v>Low risk</c:v>
                  </c:pt>
                  <c:pt idx="7">
                    <c:v>Mod. risk</c:v>
                  </c:pt>
                  <c:pt idx="8">
                    <c:v>High risk</c:v>
                  </c:pt>
                  <c:pt idx="9">
                    <c:v>Low risk</c:v>
                  </c:pt>
                  <c:pt idx="10">
                    <c:v>Mod. risk</c:v>
                  </c:pt>
                  <c:pt idx="11">
                    <c:v>High risk</c:v>
                  </c:pt>
                </c:lvl>
                <c:lvl>
                  <c:pt idx="0">
                    <c:v>Triage score only</c:v>
                  </c:pt>
                  <c:pt idx="3">
                    <c:v>Biomarker only</c:v>
                  </c:pt>
                  <c:pt idx="6">
                    <c:v>Combined (simplified)</c:v>
                  </c:pt>
                  <c:pt idx="9">
                    <c:v>Logistic model</c:v>
                  </c:pt>
                </c:lvl>
              </c:multiLvlStrCache>
            </c:multiLvlStrRef>
          </c:cat>
          <c:val>
            <c:numRef>
              <c:f>Tabelle4!$AR$86:$BC$86</c:f>
              <c:numCache>
                <c:formatCode>0.0%</c:formatCode>
                <c:ptCount val="12"/>
                <c:pt idx="0">
                  <c:v>6.3348416289592757E-2</c:v>
                </c:pt>
                <c:pt idx="1">
                  <c:v>7.9710144927536225E-2</c:v>
                </c:pt>
                <c:pt idx="2">
                  <c:v>0.13333333333333333</c:v>
                </c:pt>
                <c:pt idx="3">
                  <c:v>8.0971659919028341E-3</c:v>
                </c:pt>
                <c:pt idx="4">
                  <c:v>5.4495912806539509E-2</c:v>
                </c:pt>
                <c:pt idx="5">
                  <c:v>0.20249221183800623</c:v>
                </c:pt>
                <c:pt idx="6">
                  <c:v>1.8181818181818181E-2</c:v>
                </c:pt>
                <c:pt idx="7">
                  <c:v>6.1068702290076333E-2</c:v>
                </c:pt>
                <c:pt idx="8">
                  <c:v>0.16582914572864321</c:v>
                </c:pt>
                <c:pt idx="9">
                  <c:v>4.5248868778280547E-3</c:v>
                </c:pt>
                <c:pt idx="10">
                  <c:v>3.6885245901639344E-2</c:v>
                </c:pt>
                <c:pt idx="11">
                  <c:v>0.16382978723404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D7F-4996-9515-DA1A9CC107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3245176"/>
        <c:axId val="273245568"/>
      </c:barChart>
      <c:catAx>
        <c:axId val="273245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568"/>
        <c:crosses val="autoZero"/>
        <c:auto val="1"/>
        <c:lblAlgn val="ctr"/>
        <c:lblOffset val="100"/>
        <c:noMultiLvlLbl val="0"/>
      </c:catAx>
      <c:valAx>
        <c:axId val="273245568"/>
        <c:scaling>
          <c:orientation val="minMax"/>
          <c:max val="0.2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Risk for morta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73245176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41941" y="2356703"/>
            <a:ext cx="14075331" cy="5013407"/>
          </a:xfrm>
        </p:spPr>
        <p:txBody>
          <a:bodyPr anchor="b"/>
          <a:lstStyle>
            <a:lvl1pPr algn="ctr">
              <a:defRPr sz="1086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69902" y="7563446"/>
            <a:ext cx="12419410" cy="3476717"/>
          </a:xfrm>
        </p:spPr>
        <p:txBody>
          <a:bodyPr/>
          <a:lstStyle>
            <a:lvl1pPr marL="0" indent="0" algn="ctr">
              <a:buNone/>
              <a:defRPr sz="4346"/>
            </a:lvl1pPr>
            <a:lvl2pPr marL="827943" indent="0" algn="ctr">
              <a:buNone/>
              <a:defRPr sz="3622"/>
            </a:lvl2pPr>
            <a:lvl3pPr marL="1655887" indent="0" algn="ctr">
              <a:buNone/>
              <a:defRPr sz="3260"/>
            </a:lvl3pPr>
            <a:lvl4pPr marL="2483830" indent="0" algn="ctr">
              <a:buNone/>
              <a:defRPr sz="2897"/>
            </a:lvl4pPr>
            <a:lvl5pPr marL="3311774" indent="0" algn="ctr">
              <a:buNone/>
              <a:defRPr sz="2897"/>
            </a:lvl5pPr>
            <a:lvl6pPr marL="4139717" indent="0" algn="ctr">
              <a:buNone/>
              <a:defRPr sz="2897"/>
            </a:lvl6pPr>
            <a:lvl7pPr marL="4967661" indent="0" algn="ctr">
              <a:buNone/>
              <a:defRPr sz="2897"/>
            </a:lvl7pPr>
            <a:lvl8pPr marL="5795604" indent="0" algn="ctr">
              <a:buNone/>
              <a:defRPr sz="2897"/>
            </a:lvl8pPr>
            <a:lvl9pPr marL="6623548" indent="0" algn="ctr">
              <a:buNone/>
              <a:defRPr sz="2897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98264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1955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850188" y="766678"/>
            <a:ext cx="3570580" cy="1220351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8447" y="766678"/>
            <a:ext cx="10504751" cy="12203515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87263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08309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9822" y="3590057"/>
            <a:ext cx="14282321" cy="5990088"/>
          </a:xfrm>
        </p:spPr>
        <p:txBody>
          <a:bodyPr anchor="b"/>
          <a:lstStyle>
            <a:lvl1pPr>
              <a:defRPr sz="1086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9822" y="9636813"/>
            <a:ext cx="14282321" cy="3150046"/>
          </a:xfrm>
        </p:spPr>
        <p:txBody>
          <a:bodyPr/>
          <a:lstStyle>
            <a:lvl1pPr marL="0" indent="0">
              <a:buNone/>
              <a:defRPr sz="4346">
                <a:solidFill>
                  <a:schemeClr val="tx1"/>
                </a:solidFill>
              </a:defRPr>
            </a:lvl1pPr>
            <a:lvl2pPr marL="827943" indent="0">
              <a:buNone/>
              <a:defRPr sz="3622">
                <a:solidFill>
                  <a:schemeClr val="tx1">
                    <a:tint val="75000"/>
                  </a:schemeClr>
                </a:solidFill>
              </a:defRPr>
            </a:lvl2pPr>
            <a:lvl3pPr marL="1655887" indent="0">
              <a:buNone/>
              <a:defRPr sz="3260">
                <a:solidFill>
                  <a:schemeClr val="tx1">
                    <a:tint val="75000"/>
                  </a:schemeClr>
                </a:solidFill>
              </a:defRPr>
            </a:lvl3pPr>
            <a:lvl4pPr marL="2483830" indent="0">
              <a:buNone/>
              <a:defRPr sz="2897">
                <a:solidFill>
                  <a:schemeClr val="tx1">
                    <a:tint val="75000"/>
                  </a:schemeClr>
                </a:solidFill>
              </a:defRPr>
            </a:lvl4pPr>
            <a:lvl5pPr marL="3311774" indent="0">
              <a:buNone/>
              <a:defRPr sz="2897">
                <a:solidFill>
                  <a:schemeClr val="tx1">
                    <a:tint val="75000"/>
                  </a:schemeClr>
                </a:solidFill>
              </a:defRPr>
            </a:lvl5pPr>
            <a:lvl6pPr marL="4139717" indent="0">
              <a:buNone/>
              <a:defRPr sz="2897">
                <a:solidFill>
                  <a:schemeClr val="tx1">
                    <a:tint val="75000"/>
                  </a:schemeClr>
                </a:solidFill>
              </a:defRPr>
            </a:lvl6pPr>
            <a:lvl7pPr marL="4967661" indent="0">
              <a:buNone/>
              <a:defRPr sz="2897">
                <a:solidFill>
                  <a:schemeClr val="tx1">
                    <a:tint val="75000"/>
                  </a:schemeClr>
                </a:solidFill>
              </a:defRPr>
            </a:lvl7pPr>
            <a:lvl8pPr marL="5795604" indent="0">
              <a:buNone/>
              <a:defRPr sz="2897">
                <a:solidFill>
                  <a:schemeClr val="tx1">
                    <a:tint val="75000"/>
                  </a:schemeClr>
                </a:solidFill>
              </a:defRPr>
            </a:lvl8pPr>
            <a:lvl9pPr marL="6623548" indent="0">
              <a:buNone/>
              <a:defRPr sz="28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02483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8446" y="3833390"/>
            <a:ext cx="7037666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83101" y="3833390"/>
            <a:ext cx="7037666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74814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0603" y="766681"/>
            <a:ext cx="14282321" cy="278337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0605" y="3530053"/>
            <a:ext cx="7005322" cy="1730025"/>
          </a:xfrm>
        </p:spPr>
        <p:txBody>
          <a:bodyPr anchor="b"/>
          <a:lstStyle>
            <a:lvl1pPr marL="0" indent="0">
              <a:buNone/>
              <a:defRPr sz="4346" b="1"/>
            </a:lvl1pPr>
            <a:lvl2pPr marL="827943" indent="0">
              <a:buNone/>
              <a:defRPr sz="3622" b="1"/>
            </a:lvl2pPr>
            <a:lvl3pPr marL="1655887" indent="0">
              <a:buNone/>
              <a:defRPr sz="3260" b="1"/>
            </a:lvl3pPr>
            <a:lvl4pPr marL="2483830" indent="0">
              <a:buNone/>
              <a:defRPr sz="2897" b="1"/>
            </a:lvl4pPr>
            <a:lvl5pPr marL="3311774" indent="0">
              <a:buNone/>
              <a:defRPr sz="2897" b="1"/>
            </a:lvl5pPr>
            <a:lvl6pPr marL="4139717" indent="0">
              <a:buNone/>
              <a:defRPr sz="2897" b="1"/>
            </a:lvl6pPr>
            <a:lvl7pPr marL="4967661" indent="0">
              <a:buNone/>
              <a:defRPr sz="2897" b="1"/>
            </a:lvl7pPr>
            <a:lvl8pPr marL="5795604" indent="0">
              <a:buNone/>
              <a:defRPr sz="2897" b="1"/>
            </a:lvl8pPr>
            <a:lvl9pPr marL="6623548" indent="0">
              <a:buNone/>
              <a:defRPr sz="2897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40605" y="5260078"/>
            <a:ext cx="7005322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83103" y="3530053"/>
            <a:ext cx="7039822" cy="1730025"/>
          </a:xfrm>
        </p:spPr>
        <p:txBody>
          <a:bodyPr anchor="b"/>
          <a:lstStyle>
            <a:lvl1pPr marL="0" indent="0">
              <a:buNone/>
              <a:defRPr sz="4346" b="1"/>
            </a:lvl1pPr>
            <a:lvl2pPr marL="827943" indent="0">
              <a:buNone/>
              <a:defRPr sz="3622" b="1"/>
            </a:lvl2pPr>
            <a:lvl3pPr marL="1655887" indent="0">
              <a:buNone/>
              <a:defRPr sz="3260" b="1"/>
            </a:lvl3pPr>
            <a:lvl4pPr marL="2483830" indent="0">
              <a:buNone/>
              <a:defRPr sz="2897" b="1"/>
            </a:lvl4pPr>
            <a:lvl5pPr marL="3311774" indent="0">
              <a:buNone/>
              <a:defRPr sz="2897" b="1"/>
            </a:lvl5pPr>
            <a:lvl6pPr marL="4139717" indent="0">
              <a:buNone/>
              <a:defRPr sz="2897" b="1"/>
            </a:lvl6pPr>
            <a:lvl7pPr marL="4967661" indent="0">
              <a:buNone/>
              <a:defRPr sz="2897" b="1"/>
            </a:lvl7pPr>
            <a:lvl8pPr marL="5795604" indent="0">
              <a:buNone/>
              <a:defRPr sz="2897" b="1"/>
            </a:lvl8pPr>
            <a:lvl9pPr marL="6623548" indent="0">
              <a:buNone/>
              <a:defRPr sz="2897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83103" y="5260078"/>
            <a:ext cx="7039822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2308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1619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86677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0603" y="960014"/>
            <a:ext cx="5340777" cy="3360050"/>
          </a:xfrm>
        </p:spPr>
        <p:txBody>
          <a:bodyPr anchor="b"/>
          <a:lstStyle>
            <a:lvl1pPr>
              <a:defRPr sz="579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039822" y="2073367"/>
            <a:ext cx="8383102" cy="10233485"/>
          </a:xfrm>
        </p:spPr>
        <p:txBody>
          <a:bodyPr/>
          <a:lstStyle>
            <a:lvl1pPr>
              <a:defRPr sz="5795"/>
            </a:lvl1pPr>
            <a:lvl2pPr>
              <a:defRPr sz="5071"/>
            </a:lvl2pPr>
            <a:lvl3pPr>
              <a:defRPr sz="4346"/>
            </a:lvl3pPr>
            <a:lvl4pPr>
              <a:defRPr sz="3622"/>
            </a:lvl4pPr>
            <a:lvl5pPr>
              <a:defRPr sz="3622"/>
            </a:lvl5pPr>
            <a:lvl6pPr>
              <a:defRPr sz="3622"/>
            </a:lvl6pPr>
            <a:lvl7pPr>
              <a:defRPr sz="3622"/>
            </a:lvl7pPr>
            <a:lvl8pPr>
              <a:defRPr sz="3622"/>
            </a:lvl8pPr>
            <a:lvl9pPr>
              <a:defRPr sz="3622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0603" y="4320064"/>
            <a:ext cx="5340777" cy="8003453"/>
          </a:xfrm>
        </p:spPr>
        <p:txBody>
          <a:bodyPr/>
          <a:lstStyle>
            <a:lvl1pPr marL="0" indent="0">
              <a:buNone/>
              <a:defRPr sz="2897"/>
            </a:lvl1pPr>
            <a:lvl2pPr marL="827943" indent="0">
              <a:buNone/>
              <a:defRPr sz="2535"/>
            </a:lvl2pPr>
            <a:lvl3pPr marL="1655887" indent="0">
              <a:buNone/>
              <a:defRPr sz="2173"/>
            </a:lvl3pPr>
            <a:lvl4pPr marL="2483830" indent="0">
              <a:buNone/>
              <a:defRPr sz="1811"/>
            </a:lvl4pPr>
            <a:lvl5pPr marL="3311774" indent="0">
              <a:buNone/>
              <a:defRPr sz="1811"/>
            </a:lvl5pPr>
            <a:lvl6pPr marL="4139717" indent="0">
              <a:buNone/>
              <a:defRPr sz="1811"/>
            </a:lvl6pPr>
            <a:lvl7pPr marL="4967661" indent="0">
              <a:buNone/>
              <a:defRPr sz="1811"/>
            </a:lvl7pPr>
            <a:lvl8pPr marL="5795604" indent="0">
              <a:buNone/>
              <a:defRPr sz="1811"/>
            </a:lvl8pPr>
            <a:lvl9pPr marL="6623548" indent="0">
              <a:buNone/>
              <a:defRPr sz="181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6860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0603" y="960014"/>
            <a:ext cx="5340777" cy="3360050"/>
          </a:xfrm>
        </p:spPr>
        <p:txBody>
          <a:bodyPr anchor="b"/>
          <a:lstStyle>
            <a:lvl1pPr>
              <a:defRPr sz="579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039822" y="2073367"/>
            <a:ext cx="8383102" cy="10233485"/>
          </a:xfrm>
        </p:spPr>
        <p:txBody>
          <a:bodyPr anchor="t"/>
          <a:lstStyle>
            <a:lvl1pPr marL="0" indent="0">
              <a:buNone/>
              <a:defRPr sz="5795"/>
            </a:lvl1pPr>
            <a:lvl2pPr marL="827943" indent="0">
              <a:buNone/>
              <a:defRPr sz="5071"/>
            </a:lvl2pPr>
            <a:lvl3pPr marL="1655887" indent="0">
              <a:buNone/>
              <a:defRPr sz="4346"/>
            </a:lvl3pPr>
            <a:lvl4pPr marL="2483830" indent="0">
              <a:buNone/>
              <a:defRPr sz="3622"/>
            </a:lvl4pPr>
            <a:lvl5pPr marL="3311774" indent="0">
              <a:buNone/>
              <a:defRPr sz="3622"/>
            </a:lvl5pPr>
            <a:lvl6pPr marL="4139717" indent="0">
              <a:buNone/>
              <a:defRPr sz="3622"/>
            </a:lvl6pPr>
            <a:lvl7pPr marL="4967661" indent="0">
              <a:buNone/>
              <a:defRPr sz="3622"/>
            </a:lvl7pPr>
            <a:lvl8pPr marL="5795604" indent="0">
              <a:buNone/>
              <a:defRPr sz="3622"/>
            </a:lvl8pPr>
            <a:lvl9pPr marL="6623548" indent="0">
              <a:buNone/>
              <a:defRPr sz="3622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0603" y="4320064"/>
            <a:ext cx="5340777" cy="8003453"/>
          </a:xfrm>
        </p:spPr>
        <p:txBody>
          <a:bodyPr/>
          <a:lstStyle>
            <a:lvl1pPr marL="0" indent="0">
              <a:buNone/>
              <a:defRPr sz="2897"/>
            </a:lvl1pPr>
            <a:lvl2pPr marL="827943" indent="0">
              <a:buNone/>
              <a:defRPr sz="2535"/>
            </a:lvl2pPr>
            <a:lvl3pPr marL="1655887" indent="0">
              <a:buNone/>
              <a:defRPr sz="2173"/>
            </a:lvl3pPr>
            <a:lvl4pPr marL="2483830" indent="0">
              <a:buNone/>
              <a:defRPr sz="1811"/>
            </a:lvl4pPr>
            <a:lvl5pPr marL="3311774" indent="0">
              <a:buNone/>
              <a:defRPr sz="1811"/>
            </a:lvl5pPr>
            <a:lvl6pPr marL="4139717" indent="0">
              <a:buNone/>
              <a:defRPr sz="1811"/>
            </a:lvl6pPr>
            <a:lvl7pPr marL="4967661" indent="0">
              <a:buNone/>
              <a:defRPr sz="1811"/>
            </a:lvl7pPr>
            <a:lvl8pPr marL="5795604" indent="0">
              <a:buNone/>
              <a:defRPr sz="1811"/>
            </a:lvl8pPr>
            <a:lvl9pPr marL="6623548" indent="0">
              <a:buNone/>
              <a:defRPr sz="181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10398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8446" y="766681"/>
            <a:ext cx="14282321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8446" y="3833390"/>
            <a:ext cx="14282321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8446" y="13346867"/>
            <a:ext cx="372582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CA291-387F-4447-926B-98E2728DA952}" type="datetimeFigureOut">
              <a:rPr lang="de-CH" smtClean="0"/>
              <a:t>07.11.201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85240" y="13346867"/>
            <a:ext cx="558873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94944" y="13346867"/>
            <a:ext cx="372582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685D6-7C15-49C9-9261-B514E3551644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41806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1655887" rtl="0" eaLnBrk="1" latinLnBrk="0" hangingPunct="1">
        <a:lnSpc>
          <a:spcPct val="90000"/>
        </a:lnSpc>
        <a:spcBef>
          <a:spcPct val="0"/>
        </a:spcBef>
        <a:buNone/>
        <a:defRPr sz="79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3972" indent="-413972" algn="l" defTabSz="1655887" rtl="0" eaLnBrk="1" latinLnBrk="0" hangingPunct="1">
        <a:lnSpc>
          <a:spcPct val="90000"/>
        </a:lnSpc>
        <a:spcBef>
          <a:spcPts val="1811"/>
        </a:spcBef>
        <a:buFont typeface="Arial" panose="020B0604020202020204" pitchFamily="34" charset="0"/>
        <a:buChar char="•"/>
        <a:defRPr sz="5071" kern="1200">
          <a:solidFill>
            <a:schemeClr val="tx1"/>
          </a:solidFill>
          <a:latin typeface="+mn-lt"/>
          <a:ea typeface="+mn-ea"/>
          <a:cs typeface="+mn-cs"/>
        </a:defRPr>
      </a:lvl1pPr>
      <a:lvl2pPr marL="1241915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4346" kern="1200">
          <a:solidFill>
            <a:schemeClr val="tx1"/>
          </a:solidFill>
          <a:latin typeface="+mn-lt"/>
          <a:ea typeface="+mn-ea"/>
          <a:cs typeface="+mn-cs"/>
        </a:defRPr>
      </a:lvl2pPr>
      <a:lvl3pPr marL="2069859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622" kern="1200">
          <a:solidFill>
            <a:schemeClr val="tx1"/>
          </a:solidFill>
          <a:latin typeface="+mn-lt"/>
          <a:ea typeface="+mn-ea"/>
          <a:cs typeface="+mn-cs"/>
        </a:defRPr>
      </a:lvl3pPr>
      <a:lvl4pPr marL="2897802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260" kern="1200">
          <a:solidFill>
            <a:schemeClr val="tx1"/>
          </a:solidFill>
          <a:latin typeface="+mn-lt"/>
          <a:ea typeface="+mn-ea"/>
          <a:cs typeface="+mn-cs"/>
        </a:defRPr>
      </a:lvl4pPr>
      <a:lvl5pPr marL="3725746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260" kern="1200">
          <a:solidFill>
            <a:schemeClr val="tx1"/>
          </a:solidFill>
          <a:latin typeface="+mn-lt"/>
          <a:ea typeface="+mn-ea"/>
          <a:cs typeface="+mn-cs"/>
        </a:defRPr>
      </a:lvl5pPr>
      <a:lvl6pPr marL="4553689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260" kern="1200">
          <a:solidFill>
            <a:schemeClr val="tx1"/>
          </a:solidFill>
          <a:latin typeface="+mn-lt"/>
          <a:ea typeface="+mn-ea"/>
          <a:cs typeface="+mn-cs"/>
        </a:defRPr>
      </a:lvl6pPr>
      <a:lvl7pPr marL="5381633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260" kern="1200">
          <a:solidFill>
            <a:schemeClr val="tx1"/>
          </a:solidFill>
          <a:latin typeface="+mn-lt"/>
          <a:ea typeface="+mn-ea"/>
          <a:cs typeface="+mn-cs"/>
        </a:defRPr>
      </a:lvl7pPr>
      <a:lvl8pPr marL="6209576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260" kern="1200">
          <a:solidFill>
            <a:schemeClr val="tx1"/>
          </a:solidFill>
          <a:latin typeface="+mn-lt"/>
          <a:ea typeface="+mn-ea"/>
          <a:cs typeface="+mn-cs"/>
        </a:defRPr>
      </a:lvl8pPr>
      <a:lvl9pPr marL="7037520" indent="-413972" algn="l" defTabSz="1655887" rtl="0" eaLnBrk="1" latinLnBrk="0" hangingPunct="1">
        <a:lnSpc>
          <a:spcPct val="90000"/>
        </a:lnSpc>
        <a:spcBef>
          <a:spcPts val="905"/>
        </a:spcBef>
        <a:buFont typeface="Arial" panose="020B0604020202020204" pitchFamily="34" charset="0"/>
        <a:buChar char="•"/>
        <a:defRPr sz="3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1pPr>
      <a:lvl2pPr marL="827943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2pPr>
      <a:lvl3pPr marL="1655887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3pPr>
      <a:lvl4pPr marL="2483830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4pPr>
      <a:lvl5pPr marL="3311774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5pPr>
      <a:lvl6pPr marL="4139717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6pPr>
      <a:lvl7pPr marL="4967661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7pPr>
      <a:lvl8pPr marL="5795604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8pPr>
      <a:lvl9pPr marL="6623548" algn="l" defTabSz="1655887" rtl="0" eaLnBrk="1" latinLnBrk="0" hangingPunct="1">
        <a:defRPr sz="3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Rechteck 80"/>
          <p:cNvSpPr/>
          <p:nvPr/>
        </p:nvSpPr>
        <p:spPr>
          <a:xfrm>
            <a:off x="184540" y="109023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de-DE" sz="16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2 Fig</a:t>
            </a:r>
            <a:endParaRPr lang="de-CH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184536" y="478359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12"/>
          <p:cNvSpPr txBox="1"/>
          <p:nvPr/>
        </p:nvSpPr>
        <p:spPr>
          <a:xfrm>
            <a:off x="3297255" y="478359"/>
            <a:ext cx="1498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cute</a:t>
            </a:r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fection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8520842" y="478359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Diagramm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1637435"/>
              </p:ext>
            </p:extLst>
          </p:nvPr>
        </p:nvGraphicFramePr>
        <p:xfrm>
          <a:off x="380" y="695414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4" name="Textfeld 12"/>
          <p:cNvSpPr txBox="1"/>
          <p:nvPr/>
        </p:nvSpPr>
        <p:spPr>
          <a:xfrm>
            <a:off x="11677842" y="474686"/>
            <a:ext cx="13400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ardiovascular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184536" y="4122233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Diagramm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6231776"/>
              </p:ext>
            </p:extLst>
          </p:nvPr>
        </p:nvGraphicFramePr>
        <p:xfrm>
          <a:off x="8336306" y="691741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7" name="Textfeld 12"/>
          <p:cNvSpPr txBox="1"/>
          <p:nvPr/>
        </p:nvSpPr>
        <p:spPr>
          <a:xfrm>
            <a:off x="3296875" y="4155177"/>
            <a:ext cx="1498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Neurological</a:t>
            </a:r>
          </a:p>
        </p:txBody>
      </p:sp>
      <p:graphicFrame>
        <p:nvGraphicFramePr>
          <p:cNvPr id="31" name="Diagramm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2660115"/>
              </p:ext>
            </p:extLst>
          </p:nvPr>
        </p:nvGraphicFramePr>
        <p:xfrm>
          <a:off x="0" y="4372232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4" name="Textfeld 12"/>
          <p:cNvSpPr txBox="1"/>
          <p:nvPr/>
        </p:nvSpPr>
        <p:spPr>
          <a:xfrm>
            <a:off x="3341536" y="7680069"/>
            <a:ext cx="13400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horacic</a:t>
            </a:r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in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184536" y="7680069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Diagramm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1023436"/>
              </p:ext>
            </p:extLst>
          </p:nvPr>
        </p:nvGraphicFramePr>
        <p:xfrm>
          <a:off x="0" y="7897124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7" name="Textfeld 12"/>
          <p:cNvSpPr txBox="1"/>
          <p:nvPr/>
        </p:nvSpPr>
        <p:spPr>
          <a:xfrm>
            <a:off x="11633181" y="7680069"/>
            <a:ext cx="1498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Other </a:t>
            </a:r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in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8520842" y="7680069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9" name="Diagramm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6984630"/>
              </p:ext>
            </p:extLst>
          </p:nvPr>
        </p:nvGraphicFramePr>
        <p:xfrm>
          <a:off x="8336306" y="7897124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0" name="Textfeld 12"/>
          <p:cNvSpPr txBox="1"/>
          <p:nvPr/>
        </p:nvSpPr>
        <p:spPr>
          <a:xfrm>
            <a:off x="3103554" y="11114235"/>
            <a:ext cx="19363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Neurological </a:t>
            </a:r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ymptoms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184536" y="11174179"/>
            <a:ext cx="2792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42" name="Diagramm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8369858"/>
              </p:ext>
            </p:extLst>
          </p:nvPr>
        </p:nvGraphicFramePr>
        <p:xfrm>
          <a:off x="0" y="11391234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3" name="Textfeld 12"/>
          <p:cNvSpPr txBox="1"/>
          <p:nvPr/>
        </p:nvSpPr>
        <p:spPr>
          <a:xfrm>
            <a:off x="11120206" y="11114235"/>
            <a:ext cx="2644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spiratory</a:t>
            </a:r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ymptoms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8520842" y="11174179"/>
            <a:ext cx="3048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5" name="Diagramm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5878398"/>
              </p:ext>
            </p:extLst>
          </p:nvPr>
        </p:nvGraphicFramePr>
        <p:xfrm>
          <a:off x="8336306" y="11391234"/>
          <a:ext cx="7920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3667349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1</Words>
  <Application>Microsoft Office PowerPoint</Application>
  <PresentationFormat>Benutzerdefiniert</PresentationFormat>
  <Paragraphs>19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exander Kutz</dc:creator>
  <cp:lastModifiedBy>Alexander Kutz</cp:lastModifiedBy>
  <cp:revision>43</cp:revision>
  <dcterms:created xsi:type="dcterms:W3CDTF">2016-07-15T08:04:04Z</dcterms:created>
  <dcterms:modified xsi:type="dcterms:W3CDTF">2016-11-07T15:31:08Z</dcterms:modified>
</cp:coreProperties>
</file>